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96" y="-1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ocuments\WorkFolder\Data\Bacteria-specific%20T%20cell%20response\Study%202\IgA%20from%20saliva-10091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\Documents\WorkFolder\Data\Bacteria-specific%20T%20cell%20response\&#45936;&#51060;&#53552;&#53685;&#54633;&#48516;&#49437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>
        <c:manualLayout>
          <c:layoutTarget val="inner"/>
          <c:xMode val="edge"/>
          <c:yMode val="edge"/>
          <c:x val="0.30169643428717752"/>
          <c:y val="5.4224739513430334E-2"/>
          <c:w val="0.6462710453876197"/>
          <c:h val="0.89155052097313958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2:$S$72</c:f>
              <c:numCache>
                <c:formatCode>General</c:formatCode>
                <c:ptCount val="3"/>
                <c:pt idx="0">
                  <c:v>484.64285714285876</c:v>
                </c:pt>
                <c:pt idx="1">
                  <c:v>217.31870229007615</c:v>
                </c:pt>
                <c:pt idx="2">
                  <c:v>207.97435897435801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3:$S$73</c:f>
              <c:numCache>
                <c:formatCode>General</c:formatCode>
                <c:ptCount val="3"/>
                <c:pt idx="0">
                  <c:v>280.64935064935293</c:v>
                </c:pt>
                <c:pt idx="1">
                  <c:v>137.56679389312978</c:v>
                </c:pt>
                <c:pt idx="2">
                  <c:v>90.820512820512718</c:v>
                </c:pt>
              </c:numCache>
            </c:numRef>
          </c:yVal>
        </c:ser>
        <c:ser>
          <c:idx val="2"/>
          <c:order val="2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4:$S$74</c:f>
              <c:numCache>
                <c:formatCode>General</c:formatCode>
                <c:ptCount val="3"/>
                <c:pt idx="0">
                  <c:v>426.29870129870119</c:v>
                </c:pt>
                <c:pt idx="1">
                  <c:v>197.96755725190818</c:v>
                </c:pt>
                <c:pt idx="2">
                  <c:v>185.51282051282061</c:v>
                </c:pt>
              </c:numCache>
            </c:numRef>
          </c:yVal>
        </c:ser>
        <c:ser>
          <c:idx val="3"/>
          <c:order val="3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5:$S$75</c:f>
              <c:numCache>
                <c:formatCode>General</c:formatCode>
                <c:ptCount val="3"/>
                <c:pt idx="0">
                  <c:v>403.49476439790567</c:v>
                </c:pt>
                <c:pt idx="1">
                  <c:v>182.53073770491798</c:v>
                </c:pt>
                <c:pt idx="2">
                  <c:v>246.26666666666597</c:v>
                </c:pt>
              </c:numCache>
            </c:numRef>
          </c:yVal>
        </c:ser>
        <c:ser>
          <c:idx val="4"/>
          <c:order val="4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6:$S$76</c:f>
              <c:numCache>
                <c:formatCode>General</c:formatCode>
                <c:ptCount val="3"/>
                <c:pt idx="0">
                  <c:v>291.66230366492232</c:v>
                </c:pt>
                <c:pt idx="1">
                  <c:v>159.375</c:v>
                </c:pt>
                <c:pt idx="2">
                  <c:v>199.13333333333341</c:v>
                </c:pt>
              </c:numCache>
            </c:numRef>
          </c:yVal>
        </c:ser>
        <c:ser>
          <c:idx val="5"/>
          <c:order val="5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7:$S$77</c:f>
              <c:numCache>
                <c:formatCode>General</c:formatCode>
                <c:ptCount val="3"/>
                <c:pt idx="0">
                  <c:v>187.08333333333402</c:v>
                </c:pt>
                <c:pt idx="1">
                  <c:v>81.447126436781602</c:v>
                </c:pt>
                <c:pt idx="2">
                  <c:v>85.640243902439011</c:v>
                </c:pt>
              </c:numCache>
            </c:numRef>
          </c:yVal>
        </c:ser>
        <c:ser>
          <c:idx val="6"/>
          <c:order val="6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8:$S$78</c:f>
              <c:numCache>
                <c:formatCode>General</c:formatCode>
                <c:ptCount val="3"/>
                <c:pt idx="0">
                  <c:v>204.75490196078431</c:v>
                </c:pt>
                <c:pt idx="1">
                  <c:v>109.76130268199277</c:v>
                </c:pt>
                <c:pt idx="2">
                  <c:v>134.17682926829258</c:v>
                </c:pt>
              </c:numCache>
            </c:numRef>
          </c:yVal>
        </c:ser>
        <c:ser>
          <c:idx val="7"/>
          <c:order val="7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79:$S$79</c:f>
              <c:numCache>
                <c:formatCode>General</c:formatCode>
                <c:ptCount val="3"/>
                <c:pt idx="0">
                  <c:v>306.60404624277459</c:v>
                </c:pt>
                <c:pt idx="1">
                  <c:v>172.66221374045799</c:v>
                </c:pt>
                <c:pt idx="2">
                  <c:v>157.42718446601941</c:v>
                </c:pt>
              </c:numCache>
            </c:numRef>
          </c:yVal>
        </c:ser>
        <c:ser>
          <c:idx val="8"/>
          <c:order val="8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80:$S$80</c:f>
              <c:numCache>
                <c:formatCode>General</c:formatCode>
                <c:ptCount val="3"/>
                <c:pt idx="0">
                  <c:v>278.28534031413631</c:v>
                </c:pt>
                <c:pt idx="1">
                  <c:v>161.46516393442619</c:v>
                </c:pt>
                <c:pt idx="2">
                  <c:v>188.36666666666659</c:v>
                </c:pt>
              </c:numCache>
            </c:numRef>
          </c:yVal>
        </c:ser>
        <c:ser>
          <c:idx val="9"/>
          <c:order val="9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81:$S$81</c:f>
              <c:numCache>
                <c:formatCode>General</c:formatCode>
                <c:ptCount val="3"/>
                <c:pt idx="0">
                  <c:v>98.988439306358288</c:v>
                </c:pt>
                <c:pt idx="1">
                  <c:v>56.562500000000163</c:v>
                </c:pt>
                <c:pt idx="2">
                  <c:v>27.626146788990827</c:v>
                </c:pt>
              </c:numCache>
            </c:numRef>
          </c:yVal>
        </c:ser>
        <c:ser>
          <c:idx val="10"/>
          <c:order val="1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82:$S$82</c:f>
              <c:numCache>
                <c:formatCode>General</c:formatCode>
                <c:ptCount val="3"/>
                <c:pt idx="0">
                  <c:v>365.93930635837893</c:v>
                </c:pt>
                <c:pt idx="1">
                  <c:v>176.11641221374038</c:v>
                </c:pt>
                <c:pt idx="2">
                  <c:v>166.3349514563107</c:v>
                </c:pt>
              </c:numCache>
            </c:numRef>
          </c:yVal>
        </c:ser>
        <c:ser>
          <c:idx val="11"/>
          <c:order val="11"/>
          <c:spPr>
            <a:ln w="28575">
              <a:noFill/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83:$S$83</c:f>
              <c:numCache>
                <c:formatCode>General</c:formatCode>
                <c:ptCount val="3"/>
              </c:numCache>
            </c:numRef>
          </c:yVal>
        </c:ser>
        <c:ser>
          <c:idx val="12"/>
          <c:order val="12"/>
          <c:spPr>
            <a:ln w="28575">
              <a:noFill/>
            </a:ln>
          </c:spPr>
          <c:marker>
            <c:symbol val="dash"/>
            <c:size val="1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FADA-IgA'!$Q$71:$S$71</c:f>
              <c:strCache>
                <c:ptCount val="3"/>
                <c:pt idx="0">
                  <c:v>Healthy</c:v>
                </c:pt>
                <c:pt idx="1">
                  <c:v>Healthy</c:v>
                </c:pt>
                <c:pt idx="2">
                  <c:v>Healthy</c:v>
                </c:pt>
              </c:strCache>
            </c:strRef>
          </c:xVal>
          <c:yVal>
            <c:numRef>
              <c:f>'FADA-IgA'!$Q$84:$S$84</c:f>
              <c:numCache>
                <c:formatCode>General</c:formatCode>
                <c:ptCount val="3"/>
                <c:pt idx="0">
                  <c:v>286.15582715713708</c:v>
                </c:pt>
                <c:pt idx="1">
                  <c:v>160.42008196721406</c:v>
                </c:pt>
                <c:pt idx="2">
                  <c:v>171.47000248942001</c:v>
                </c:pt>
              </c:numCache>
            </c:numRef>
          </c:yVal>
        </c:ser>
        <c:axId val="118880512"/>
        <c:axId val="118952704"/>
      </c:scatterChart>
      <c:valAx>
        <c:axId val="118880512"/>
        <c:scaling>
          <c:orientation val="minMax"/>
        </c:scaling>
        <c:axPos val="b"/>
        <c:numFmt formatCode="General" sourceLinked="1"/>
        <c:majorTickMark val="none"/>
        <c:tickLblPos val="none"/>
        <c:spPr>
          <a:ln w="15875">
            <a:solidFill>
              <a:schemeClr val="tx1"/>
            </a:solidFill>
          </a:ln>
        </c:spPr>
        <c:crossAx val="118952704"/>
        <c:crossesAt val="1.0000000000000007E-2"/>
        <c:crossBetween val="midCat"/>
      </c:valAx>
      <c:valAx>
        <c:axId val="118952704"/>
        <c:scaling>
          <c:logBase val="10"/>
          <c:orientation val="minMax"/>
          <c:max val="10000"/>
          <c:min val="0.1"/>
        </c:scaling>
        <c:axPos val="l"/>
        <c:numFmt formatCode="0_);\(0\)" sourceLinked="0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Calibri" pitchFamily="34" charset="0"/>
                <a:cs typeface="Calibri" pitchFamily="34" charset="0"/>
              </a:defRPr>
            </a:pPr>
            <a:endParaRPr lang="ko-KR"/>
          </a:p>
        </c:txPr>
        <c:crossAx val="11888051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plotArea>
      <c:layout/>
      <c:scatterChart>
        <c:scatterStyle val="lineMarker"/>
        <c:ser>
          <c:idx val="0"/>
          <c:order val="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18:$L$18</c:f>
              <c:numCache>
                <c:formatCode>0.0_ </c:formatCode>
                <c:ptCount val="11"/>
                <c:pt idx="0">
                  <c:v>490.06734006734018</c:v>
                </c:pt>
                <c:pt idx="1">
                  <c:v>597.29835552075542</c:v>
                </c:pt>
                <c:pt idx="2">
                  <c:v>173.56828193832601</c:v>
                </c:pt>
                <c:pt idx="4">
                  <c:v>1620.9484924623109</c:v>
                </c:pt>
                <c:pt idx="5">
                  <c:v>259.72361809045219</c:v>
                </c:pt>
                <c:pt idx="6">
                  <c:v>4428.7425149700603</c:v>
                </c:pt>
                <c:pt idx="8">
                  <c:v>56.82844243792325</c:v>
                </c:pt>
                <c:pt idx="9">
                  <c:v>1.7231329690346071</c:v>
                </c:pt>
                <c:pt idx="10">
                  <c:v>510.91954022988511</c:v>
                </c:pt>
              </c:numCache>
            </c:numRef>
          </c:yVal>
        </c:ser>
        <c:ser>
          <c:idx val="1"/>
          <c:order val="1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19:$L$19</c:f>
              <c:numCache>
                <c:formatCode>0.0_ </c:formatCode>
                <c:ptCount val="11"/>
                <c:pt idx="0">
                  <c:v>440.74074074074082</c:v>
                </c:pt>
                <c:pt idx="1">
                  <c:v>243.34377447141676</c:v>
                </c:pt>
                <c:pt idx="2">
                  <c:v>184.14096916299559</c:v>
                </c:pt>
                <c:pt idx="4">
                  <c:v>868.99038461538555</c:v>
                </c:pt>
                <c:pt idx="5">
                  <c:v>563.49246231155769</c:v>
                </c:pt>
                <c:pt idx="6">
                  <c:v>1068.619582664526</c:v>
                </c:pt>
                <c:pt idx="8">
                  <c:v>12.697516930022569</c:v>
                </c:pt>
                <c:pt idx="9">
                  <c:v>1.775000000000015</c:v>
                </c:pt>
                <c:pt idx="10">
                  <c:v>0.86587436332766798</c:v>
                </c:pt>
              </c:numCache>
            </c:numRef>
          </c:yVal>
        </c:ser>
        <c:ser>
          <c:idx val="2"/>
          <c:order val="2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0:$L$20</c:f>
              <c:numCache>
                <c:formatCode>0.0_ </c:formatCode>
                <c:ptCount val="11"/>
                <c:pt idx="0">
                  <c:v>135.43771043771102</c:v>
                </c:pt>
                <c:pt idx="1">
                  <c:v>106.5779169929522</c:v>
                </c:pt>
                <c:pt idx="2">
                  <c:v>8.8019559902200477</c:v>
                </c:pt>
                <c:pt idx="4">
                  <c:v>1751.476130653266</c:v>
                </c:pt>
                <c:pt idx="5">
                  <c:v>279.43069306930698</c:v>
                </c:pt>
                <c:pt idx="6">
                  <c:v>6297.029702970297</c:v>
                </c:pt>
                <c:pt idx="8">
                  <c:v>46.065573770492009</c:v>
                </c:pt>
                <c:pt idx="9">
                  <c:v>1.8233151183970839</c:v>
                </c:pt>
                <c:pt idx="10">
                  <c:v>284.3525179856116</c:v>
                </c:pt>
              </c:numCache>
            </c:numRef>
          </c:yVal>
        </c:ser>
        <c:ser>
          <c:idx val="3"/>
          <c:order val="3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1:$L$21</c:f>
              <c:numCache>
                <c:formatCode>0.0_ </c:formatCode>
                <c:ptCount val="11"/>
                <c:pt idx="0">
                  <c:v>110.43771043771052</c:v>
                </c:pt>
                <c:pt idx="1">
                  <c:v>101.72278778386809</c:v>
                </c:pt>
                <c:pt idx="2">
                  <c:v>7.457212713936423</c:v>
                </c:pt>
                <c:pt idx="4">
                  <c:v>376.32211538461519</c:v>
                </c:pt>
                <c:pt idx="5">
                  <c:v>296.13861386138609</c:v>
                </c:pt>
                <c:pt idx="6">
                  <c:v>4277.227722772278</c:v>
                </c:pt>
                <c:pt idx="8">
                  <c:v>205.1639344262295</c:v>
                </c:pt>
                <c:pt idx="9">
                  <c:v>27.587500000000009</c:v>
                </c:pt>
                <c:pt idx="10">
                  <c:v>137.2302158273381</c:v>
                </c:pt>
              </c:numCache>
            </c:numRef>
          </c:yVal>
        </c:ser>
        <c:ser>
          <c:idx val="4"/>
          <c:order val="4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2:$L$22</c:f>
              <c:numCache>
                <c:formatCode>0.0_ </c:formatCode>
                <c:ptCount val="11"/>
                <c:pt idx="0">
                  <c:v>215.73634204275541</c:v>
                </c:pt>
                <c:pt idx="1">
                  <c:v>165.11147811725851</c:v>
                </c:pt>
                <c:pt idx="2">
                  <c:v>38.141809290953496</c:v>
                </c:pt>
                <c:pt idx="4">
                  <c:v>797.4476439790576</c:v>
                </c:pt>
                <c:pt idx="5">
                  <c:v>458.59374999999869</c:v>
                </c:pt>
                <c:pt idx="6">
                  <c:v>2496.6996699669844</c:v>
                </c:pt>
                <c:pt idx="8">
                  <c:v>2.3443478260869601</c:v>
                </c:pt>
                <c:pt idx="9">
                  <c:v>9.1183970856101126</c:v>
                </c:pt>
                <c:pt idx="10">
                  <c:v>94.424460431654651</c:v>
                </c:pt>
              </c:numCache>
            </c:numRef>
          </c:yVal>
        </c:ser>
        <c:ser>
          <c:idx val="5"/>
          <c:order val="5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3:$L$23</c:f>
              <c:numCache>
                <c:formatCode>0.0_ </c:formatCode>
                <c:ptCount val="11"/>
                <c:pt idx="0">
                  <c:v>136.87648456057011</c:v>
                </c:pt>
                <c:pt idx="1">
                  <c:v>88.769611890999172</c:v>
                </c:pt>
                <c:pt idx="2">
                  <c:v>150.86206896551741</c:v>
                </c:pt>
                <c:pt idx="4">
                  <c:v>1440.379581151833</c:v>
                </c:pt>
                <c:pt idx="5">
                  <c:v>439.48317307692116</c:v>
                </c:pt>
                <c:pt idx="6">
                  <c:v>2363.8613861386152</c:v>
                </c:pt>
                <c:pt idx="8">
                  <c:v>0.97043478260869864</c:v>
                </c:pt>
                <c:pt idx="9">
                  <c:v>0</c:v>
                </c:pt>
                <c:pt idx="10">
                  <c:v>31.654676258992811</c:v>
                </c:pt>
              </c:numCache>
            </c:numRef>
          </c:yVal>
        </c:ser>
        <c:ser>
          <c:idx val="6"/>
          <c:order val="6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4:$L$24</c:f>
              <c:numCache>
                <c:formatCode>0.0_ </c:formatCode>
                <c:ptCount val="11"/>
                <c:pt idx="0">
                  <c:v>184.67933491686458</c:v>
                </c:pt>
                <c:pt idx="1">
                  <c:v>146.73823286540087</c:v>
                </c:pt>
                <c:pt idx="2">
                  <c:v>151.77865612648156</c:v>
                </c:pt>
                <c:pt idx="4">
                  <c:v>755.95549738219836</c:v>
                </c:pt>
                <c:pt idx="5">
                  <c:v>544.7772277227723</c:v>
                </c:pt>
                <c:pt idx="6">
                  <c:v>54359.880239521139</c:v>
                </c:pt>
                <c:pt idx="8">
                  <c:v>100.42857142857125</c:v>
                </c:pt>
                <c:pt idx="9">
                  <c:v>23.579710144927489</c:v>
                </c:pt>
                <c:pt idx="10">
                  <c:v>1143.7793427230049</c:v>
                </c:pt>
              </c:numCache>
            </c:numRef>
          </c:yVal>
        </c:ser>
        <c:ser>
          <c:idx val="7"/>
          <c:order val="7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5:$L$25</c:f>
              <c:numCache>
                <c:formatCode>0.0_ </c:formatCode>
                <c:ptCount val="11"/>
                <c:pt idx="0">
                  <c:v>150.2969121140143</c:v>
                </c:pt>
                <c:pt idx="1">
                  <c:v>91.329479768785959</c:v>
                </c:pt>
                <c:pt idx="2">
                  <c:v>413.79310344827076</c:v>
                </c:pt>
                <c:pt idx="4">
                  <c:v>536.58376963350804</c:v>
                </c:pt>
                <c:pt idx="5">
                  <c:v>232.6322115384616</c:v>
                </c:pt>
                <c:pt idx="6">
                  <c:v>8128.1179138321995</c:v>
                </c:pt>
                <c:pt idx="8">
                  <c:v>0.45238095238095555</c:v>
                </c:pt>
                <c:pt idx="9">
                  <c:v>3.6521739130434767</c:v>
                </c:pt>
                <c:pt idx="10">
                  <c:v>21.009389671361298</c:v>
                </c:pt>
              </c:numCache>
            </c:numRef>
          </c:yVal>
        </c:ser>
        <c:ser>
          <c:idx val="8"/>
          <c:order val="8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6:$L$26</c:f>
              <c:numCache>
                <c:formatCode>0.0_ </c:formatCode>
                <c:ptCount val="11"/>
                <c:pt idx="0">
                  <c:v>156.26315789473617</c:v>
                </c:pt>
                <c:pt idx="1">
                  <c:v>171.53652392947075</c:v>
                </c:pt>
                <c:pt idx="2">
                  <c:v>108.1293706293706</c:v>
                </c:pt>
                <c:pt idx="4">
                  <c:v>301.46067415730334</c:v>
                </c:pt>
                <c:pt idx="5">
                  <c:v>335.61827956989225</c:v>
                </c:pt>
                <c:pt idx="6">
                  <c:v>496.10778443113782</c:v>
                </c:pt>
                <c:pt idx="8">
                  <c:v>18.340857787810528</c:v>
                </c:pt>
                <c:pt idx="9">
                  <c:v>23.48991696322657</c:v>
                </c:pt>
                <c:pt idx="10">
                  <c:v>52.571189279731975</c:v>
                </c:pt>
              </c:numCache>
            </c:numRef>
          </c:yVal>
        </c:ser>
        <c:ser>
          <c:idx val="9"/>
          <c:order val="9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7:$L$27</c:f>
              <c:numCache>
                <c:formatCode>0.0_ </c:formatCode>
                <c:ptCount val="11"/>
                <c:pt idx="0">
                  <c:v>71.947368421053014</c:v>
                </c:pt>
                <c:pt idx="1">
                  <c:v>79.596977329974749</c:v>
                </c:pt>
                <c:pt idx="2">
                  <c:v>29.195804195804278</c:v>
                </c:pt>
                <c:pt idx="4">
                  <c:v>343.31460674157199</c:v>
                </c:pt>
                <c:pt idx="5">
                  <c:v>352.41935483870924</c:v>
                </c:pt>
                <c:pt idx="6">
                  <c:v>0.1</c:v>
                </c:pt>
                <c:pt idx="8">
                  <c:v>4</c:v>
                </c:pt>
                <c:pt idx="9">
                  <c:v>1.2419928825622724</c:v>
                </c:pt>
                <c:pt idx="10">
                  <c:v>0.1</c:v>
                </c:pt>
              </c:numCache>
            </c:numRef>
          </c:yVal>
        </c:ser>
        <c:ser>
          <c:idx val="10"/>
          <c:order val="10"/>
          <c:spPr>
            <a:ln w="28575">
              <a:noFill/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8:$L$28</c:f>
              <c:numCache>
                <c:formatCode>0.0_ </c:formatCode>
                <c:ptCount val="11"/>
                <c:pt idx="0">
                  <c:v>81.105263157894299</c:v>
                </c:pt>
                <c:pt idx="1">
                  <c:v>84.256926952141072</c:v>
                </c:pt>
                <c:pt idx="2">
                  <c:v>224.21328671328658</c:v>
                </c:pt>
                <c:pt idx="4">
                  <c:v>257.07865168539331</c:v>
                </c:pt>
                <c:pt idx="5">
                  <c:v>303.09139784946194</c:v>
                </c:pt>
                <c:pt idx="6">
                  <c:v>83395.508982035957</c:v>
                </c:pt>
                <c:pt idx="8">
                  <c:v>15.63205417607225</c:v>
                </c:pt>
                <c:pt idx="9">
                  <c:v>6.7758007117437824</c:v>
                </c:pt>
                <c:pt idx="10">
                  <c:v>256.59128978224265</c:v>
                </c:pt>
              </c:numCache>
            </c:numRef>
          </c:yVal>
        </c:ser>
        <c:ser>
          <c:idx val="11"/>
          <c:order val="11"/>
          <c:spPr>
            <a:ln w="28575">
              <a:noFill/>
            </a:ln>
          </c:spPr>
          <c:marker>
            <c:symbol val="dash"/>
            <c:size val="16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'Ab-Healthy'!$B$17:$L$17</c:f>
              <c:strCache>
                <c:ptCount val="11"/>
                <c:pt idx="0">
                  <c:v>FADA</c:v>
                </c:pt>
                <c:pt idx="1">
                  <c:v>Td92</c:v>
                </c:pt>
                <c:pt idx="2">
                  <c:v>TT</c:v>
                </c:pt>
                <c:pt idx="4">
                  <c:v>FADA</c:v>
                </c:pt>
                <c:pt idx="5">
                  <c:v>Td92</c:v>
                </c:pt>
                <c:pt idx="6">
                  <c:v>TT</c:v>
                </c:pt>
                <c:pt idx="8">
                  <c:v>FADA</c:v>
                </c:pt>
                <c:pt idx="9">
                  <c:v>Td92</c:v>
                </c:pt>
                <c:pt idx="10">
                  <c:v>TT</c:v>
                </c:pt>
              </c:strCache>
            </c:strRef>
          </c:xVal>
          <c:yVal>
            <c:numRef>
              <c:f>'Ab-Healthy'!$B$29:$L$29</c:f>
              <c:numCache>
                <c:formatCode>0.0;_铿</c:formatCode>
                <c:ptCount val="11"/>
                <c:pt idx="0">
                  <c:v>143.58669833729306</c:v>
                </c:pt>
                <c:pt idx="1">
                  <c:v>104.15035238840998</c:v>
                </c:pt>
                <c:pt idx="2">
                  <c:v>129.495719797444</c:v>
                </c:pt>
                <c:pt idx="4">
                  <c:v>646.26963350785354</c:v>
                </c:pt>
                <c:pt idx="5">
                  <c:v>344.01881720430111</c:v>
                </c:pt>
                <c:pt idx="6">
                  <c:v>3386.9636963696357</c:v>
                </c:pt>
                <c:pt idx="8">
                  <c:v>14.164785553047448</c:v>
                </c:pt>
                <c:pt idx="9">
                  <c:v>5.2139873123936313</c:v>
                </c:pt>
                <c:pt idx="10">
                  <c:v>73.497824855693324</c:v>
                </c:pt>
              </c:numCache>
            </c:numRef>
          </c:yVal>
        </c:ser>
        <c:axId val="138158464"/>
        <c:axId val="138160384"/>
      </c:scatterChart>
      <c:valAx>
        <c:axId val="138158464"/>
        <c:scaling>
          <c:orientation val="minMax"/>
        </c:scaling>
        <c:axPos val="b"/>
        <c:tickLblPos val="none"/>
        <c:spPr>
          <a:ln w="15875">
            <a:solidFill>
              <a:sysClr val="windowText" lastClr="000000"/>
            </a:solidFill>
          </a:ln>
        </c:spPr>
        <c:crossAx val="138160384"/>
        <c:crossesAt val="0.1"/>
        <c:crossBetween val="midCat"/>
        <c:majorUnit val="4"/>
      </c:valAx>
      <c:valAx>
        <c:axId val="138160384"/>
        <c:scaling>
          <c:logBase val="10"/>
          <c:orientation val="minMax"/>
          <c:max val="100000"/>
          <c:min val="0.1"/>
        </c:scaling>
        <c:axPos val="l"/>
        <c:numFmt formatCode="0_ " sourceLinked="0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Calibri" pitchFamily="34" charset="0"/>
                <a:cs typeface="Calibri" pitchFamily="34" charset="0"/>
              </a:defRPr>
            </a:pPr>
            <a:endParaRPr lang="ko-KR"/>
          </a:p>
        </c:txPr>
        <c:crossAx val="138158464"/>
        <c:crossesAt val="0"/>
        <c:crossBetween val="midCat"/>
      </c:valAx>
    </c:plotArea>
    <c:plotVisOnly val="1"/>
    <c:dispBlanksAs val="gap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A6007-C266-4BAA-B403-C2DB458BF6F5}" type="datetimeFigureOut">
              <a:rPr lang="ko-KR" altLang="en-US" smtClean="0"/>
              <a:t>2012-12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9017A-9E0F-413F-9E16-35AA3E180B32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301" name="TextBox 59"/>
          <p:cNvSpPr txBox="1">
            <a:spLocks noChangeArrowheads="1"/>
          </p:cNvSpPr>
          <p:nvPr/>
        </p:nvSpPr>
        <p:spPr bwMode="auto">
          <a:xfrm>
            <a:off x="6165043" y="875539"/>
            <a:ext cx="144897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ko-KR" sz="1600" dirty="0" smtClean="0">
                <a:latin typeface="Calibri" pitchFamily="34" charset="0"/>
                <a:cs typeface="Calibri" pitchFamily="34" charset="0"/>
              </a:rPr>
              <a:t>Saliva</a:t>
            </a:r>
            <a:endParaRPr lang="ko-KR" altLang="en-US" sz="16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4295" name="TextBox 1"/>
          <p:cNvSpPr txBox="1">
            <a:spLocks noChangeArrowheads="1"/>
          </p:cNvSpPr>
          <p:nvPr/>
        </p:nvSpPr>
        <p:spPr bwMode="auto">
          <a:xfrm rot="16200000">
            <a:off x="6207280" y="4060515"/>
            <a:ext cx="61201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kumimoji="0" lang="en-US" altLang="ko-KR" sz="1200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FadA</a:t>
            </a:r>
            <a:endParaRPr kumimoji="0" lang="ko-KR" altLang="en-US" sz="1200" dirty="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cxnSp>
        <p:nvCxnSpPr>
          <p:cNvPr id="64" name="직선 연결선 63"/>
          <p:cNvCxnSpPr/>
          <p:nvPr/>
        </p:nvCxnSpPr>
        <p:spPr bwMode="auto">
          <a:xfrm>
            <a:off x="6467260" y="4470352"/>
            <a:ext cx="6921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297" name="TextBox 11"/>
          <p:cNvSpPr txBox="1">
            <a:spLocks noChangeArrowheads="1"/>
          </p:cNvSpPr>
          <p:nvPr/>
        </p:nvSpPr>
        <p:spPr bwMode="auto">
          <a:xfrm>
            <a:off x="6450935" y="4444331"/>
            <a:ext cx="76105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kumimoji="0" lang="en-US" altLang="ko-KR" sz="1400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sIgA</a:t>
            </a:r>
            <a:endParaRPr kumimoji="0" lang="ko-KR" altLang="en-US" sz="1400" dirty="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sp>
        <p:nvSpPr>
          <p:cNvPr id="54298" name="TextBox 1"/>
          <p:cNvSpPr txBox="1">
            <a:spLocks noChangeArrowheads="1"/>
          </p:cNvSpPr>
          <p:nvPr/>
        </p:nvSpPr>
        <p:spPr bwMode="auto">
          <a:xfrm rot="16200000">
            <a:off x="6502086" y="4060515"/>
            <a:ext cx="61201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kumimoji="0" lang="en-US" altLang="ko-KR" sz="1200">
                <a:latin typeface="Calibri" pitchFamily="34" charset="0"/>
                <a:ea typeface="맑은 고딕" pitchFamily="50" charset="-127"/>
                <a:cs typeface="Calibri" pitchFamily="34" charset="0"/>
              </a:rPr>
              <a:t>Td92</a:t>
            </a:r>
            <a:endParaRPr kumimoji="0" lang="ko-KR" altLang="en-US" sz="120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sp>
        <p:nvSpPr>
          <p:cNvPr id="54299" name="TextBox 1"/>
          <p:cNvSpPr txBox="1">
            <a:spLocks noChangeArrowheads="1"/>
          </p:cNvSpPr>
          <p:nvPr/>
        </p:nvSpPr>
        <p:spPr bwMode="auto">
          <a:xfrm rot="16200000">
            <a:off x="6879550" y="3991844"/>
            <a:ext cx="47178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kumimoji="0" lang="en-US" altLang="ko-KR" sz="1200">
                <a:latin typeface="Calibri" pitchFamily="34" charset="0"/>
                <a:ea typeface="맑은 고딕" pitchFamily="50" charset="-127"/>
                <a:cs typeface="Calibri" pitchFamily="34" charset="0"/>
              </a:rPr>
              <a:t>TT</a:t>
            </a:r>
            <a:endParaRPr kumimoji="0" lang="ko-KR" altLang="en-US" sz="120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sp>
        <p:nvSpPr>
          <p:cNvPr id="54278" name="TextBox 36"/>
          <p:cNvSpPr txBox="1">
            <a:spLocks noChangeArrowheads="1"/>
          </p:cNvSpPr>
          <p:nvPr/>
        </p:nvSpPr>
        <p:spPr bwMode="auto">
          <a:xfrm rot="16200000">
            <a:off x="5100159" y="2504100"/>
            <a:ext cx="10096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ko-KR" sz="1200" b="1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Ig</a:t>
            </a:r>
            <a:r>
              <a:rPr lang="en-US" altLang="ko-KR" sz="1200" b="1" dirty="0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 </a:t>
            </a:r>
            <a:r>
              <a:rPr kumimoji="0" lang="en-US" altLang="ko-KR" sz="1200" b="1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ng</a:t>
            </a:r>
            <a:r>
              <a:rPr kumimoji="0" lang="en-US" altLang="ko-KR" sz="1200" b="1" dirty="0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/ml</a:t>
            </a:r>
            <a:endParaRPr kumimoji="0" lang="ko-KR" altLang="en-US" sz="1200" b="1" dirty="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graphicFrame>
        <p:nvGraphicFramePr>
          <p:cNvPr id="83" name="차트 82"/>
          <p:cNvGraphicFramePr/>
          <p:nvPr/>
        </p:nvGraphicFramePr>
        <p:xfrm>
          <a:off x="5633820" y="1388900"/>
          <a:ext cx="1952625" cy="26003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그룹 85"/>
          <p:cNvGrpSpPr/>
          <p:nvPr/>
        </p:nvGrpSpPr>
        <p:grpSpPr>
          <a:xfrm>
            <a:off x="1691875" y="3932123"/>
            <a:ext cx="3382910" cy="893565"/>
            <a:chOff x="1911370" y="5274034"/>
            <a:chExt cx="3382910" cy="893565"/>
          </a:xfrm>
        </p:grpSpPr>
        <p:sp>
          <p:nvSpPr>
            <p:cNvPr id="54303" name="TextBox 1"/>
            <p:cNvSpPr txBox="1">
              <a:spLocks noChangeArrowheads="1"/>
            </p:cNvSpPr>
            <p:nvPr/>
          </p:nvSpPr>
          <p:spPr bwMode="auto">
            <a:xfrm rot="16200000">
              <a:off x="1743482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2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193" name="직선 연결선 192"/>
            <p:cNvCxnSpPr/>
            <p:nvPr/>
          </p:nvCxnSpPr>
          <p:spPr bwMode="auto">
            <a:xfrm>
              <a:off x="2005432" y="5851884"/>
              <a:ext cx="6921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305" name="TextBox 11"/>
            <p:cNvSpPr txBox="1">
              <a:spLocks noChangeArrowheads="1"/>
            </p:cNvSpPr>
            <p:nvPr/>
          </p:nvSpPr>
          <p:spPr bwMode="auto">
            <a:xfrm>
              <a:off x="1987958" y="5859822"/>
              <a:ext cx="761992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4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gA</a:t>
              </a:r>
              <a:endParaRPr kumimoji="0" lang="ko-KR" altLang="en-US" sz="14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195" name="직선 연결선 194"/>
            <p:cNvCxnSpPr/>
            <p:nvPr/>
          </p:nvCxnSpPr>
          <p:spPr bwMode="auto">
            <a:xfrm>
              <a:off x="3311944" y="5851884"/>
              <a:ext cx="69373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307" name="TextBox 13"/>
            <p:cNvSpPr txBox="1">
              <a:spLocks noChangeArrowheads="1"/>
            </p:cNvSpPr>
            <p:nvPr/>
          </p:nvSpPr>
          <p:spPr bwMode="auto">
            <a:xfrm>
              <a:off x="3264294" y="5859822"/>
              <a:ext cx="76040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4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gG1</a:t>
              </a:r>
              <a:endParaRPr kumimoji="0" lang="ko-KR" altLang="en-US" sz="14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08" name="TextBox 14"/>
            <p:cNvSpPr txBox="1">
              <a:spLocks noChangeArrowheads="1"/>
            </p:cNvSpPr>
            <p:nvPr/>
          </p:nvSpPr>
          <p:spPr bwMode="auto">
            <a:xfrm>
              <a:off x="4475544" y="5859822"/>
              <a:ext cx="76040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kumimoji="0" lang="en-US" altLang="ko-KR" sz="1400" dirty="0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IgG4</a:t>
              </a:r>
              <a:endParaRPr kumimoji="0" lang="ko-KR" altLang="en-US" sz="14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cxnSp>
          <p:nvCxnSpPr>
            <p:cNvPr id="198" name="직선 연결선 72"/>
            <p:cNvCxnSpPr/>
            <p:nvPr/>
          </p:nvCxnSpPr>
          <p:spPr bwMode="auto">
            <a:xfrm>
              <a:off x="4513682" y="5851884"/>
              <a:ext cx="6921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310" name="TextBox 1"/>
            <p:cNvSpPr txBox="1">
              <a:spLocks noChangeArrowheads="1"/>
            </p:cNvSpPr>
            <p:nvPr/>
          </p:nvSpPr>
          <p:spPr bwMode="auto">
            <a:xfrm rot="16200000">
              <a:off x="2038754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1" name="TextBox 1"/>
            <p:cNvSpPr txBox="1">
              <a:spLocks noChangeArrowheads="1"/>
            </p:cNvSpPr>
            <p:nvPr/>
          </p:nvSpPr>
          <p:spPr bwMode="auto">
            <a:xfrm rot="16200000">
              <a:off x="2417370" y="5372866"/>
              <a:ext cx="4714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2" name="TextBox 1"/>
            <p:cNvSpPr txBox="1">
              <a:spLocks noChangeArrowheads="1"/>
            </p:cNvSpPr>
            <p:nvPr/>
          </p:nvSpPr>
          <p:spPr bwMode="auto">
            <a:xfrm rot="16200000">
              <a:off x="3061093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2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3" name="TextBox 1"/>
            <p:cNvSpPr txBox="1">
              <a:spLocks noChangeArrowheads="1"/>
            </p:cNvSpPr>
            <p:nvPr/>
          </p:nvSpPr>
          <p:spPr bwMode="auto">
            <a:xfrm rot="16200000">
              <a:off x="3354777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4" name="TextBox 1"/>
            <p:cNvSpPr txBox="1">
              <a:spLocks noChangeArrowheads="1"/>
            </p:cNvSpPr>
            <p:nvPr/>
          </p:nvSpPr>
          <p:spPr bwMode="auto">
            <a:xfrm rot="16200000">
              <a:off x="3733393" y="5372866"/>
              <a:ext cx="4714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5" name="TextBox 1"/>
            <p:cNvSpPr txBox="1">
              <a:spLocks noChangeArrowheads="1"/>
            </p:cNvSpPr>
            <p:nvPr/>
          </p:nvSpPr>
          <p:spPr bwMode="auto">
            <a:xfrm rot="16200000">
              <a:off x="4246942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 dirty="0" err="1" smtClean="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FadA</a:t>
              </a:r>
              <a:endParaRPr kumimoji="0" lang="ko-KR" altLang="en-US" sz="1200" dirty="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6" name="TextBox 1"/>
            <p:cNvSpPr txBox="1">
              <a:spLocks noChangeArrowheads="1"/>
            </p:cNvSpPr>
            <p:nvPr/>
          </p:nvSpPr>
          <p:spPr bwMode="auto">
            <a:xfrm rot="16200000">
              <a:off x="4542214" y="5441922"/>
              <a:ext cx="6127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d92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  <p:sp>
          <p:nvSpPr>
            <p:cNvPr id="54317" name="TextBox 1"/>
            <p:cNvSpPr txBox="1">
              <a:spLocks noChangeArrowheads="1"/>
            </p:cNvSpPr>
            <p:nvPr/>
          </p:nvSpPr>
          <p:spPr bwMode="auto">
            <a:xfrm rot="16200000">
              <a:off x="4920037" y="5372866"/>
              <a:ext cx="4714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r"/>
              <a:r>
                <a:rPr kumimoji="0" lang="en-US" altLang="ko-KR" sz="1200">
                  <a:latin typeface="Calibri" pitchFamily="34" charset="0"/>
                  <a:ea typeface="맑은 고딕" pitchFamily="50" charset="-127"/>
                  <a:cs typeface="Calibri" pitchFamily="34" charset="0"/>
                </a:rPr>
                <a:t>TT</a:t>
              </a:r>
              <a:endParaRPr kumimoji="0" lang="ko-KR" altLang="en-US" sz="1200">
                <a:latin typeface="Calibri" pitchFamily="34" charset="0"/>
                <a:ea typeface="맑은 고딕" pitchFamily="50" charset="-127"/>
                <a:cs typeface="Calibri" pitchFamily="34" charset="0"/>
              </a:endParaRPr>
            </a:p>
          </p:txBody>
        </p:sp>
      </p:grpSp>
      <p:sp>
        <p:nvSpPr>
          <p:cNvPr id="54340" name="TextBox 214"/>
          <p:cNvSpPr txBox="1">
            <a:spLocks noChangeArrowheads="1"/>
          </p:cNvSpPr>
          <p:nvPr/>
        </p:nvSpPr>
        <p:spPr bwMode="auto">
          <a:xfrm>
            <a:off x="3365461" y="1256332"/>
            <a:ext cx="4626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4342" name="TextBox 213"/>
          <p:cNvSpPr txBox="1">
            <a:spLocks noChangeArrowheads="1"/>
          </p:cNvSpPr>
          <p:nvPr/>
        </p:nvSpPr>
        <p:spPr bwMode="auto">
          <a:xfrm>
            <a:off x="3113531" y="1256336"/>
            <a:ext cx="22679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>
                <a:latin typeface="Calibri" pitchFamily="34" charset="0"/>
                <a:cs typeface="Calibri" pitchFamily="34" charset="0"/>
              </a:rPr>
              <a:t>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4343" name="TextBox 215"/>
          <p:cNvSpPr txBox="1">
            <a:spLocks noChangeArrowheads="1"/>
          </p:cNvSpPr>
          <p:nvPr/>
        </p:nvSpPr>
        <p:spPr bwMode="auto">
          <a:xfrm>
            <a:off x="3228957" y="1144205"/>
            <a:ext cx="39654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4323" name="TextBox 59"/>
          <p:cNvSpPr txBox="1">
            <a:spLocks noChangeArrowheads="1"/>
          </p:cNvSpPr>
          <p:nvPr/>
        </p:nvSpPr>
        <p:spPr bwMode="auto">
          <a:xfrm>
            <a:off x="2544702" y="851258"/>
            <a:ext cx="165574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ko-KR" sz="1600" dirty="0" smtClean="0">
                <a:latin typeface="Calibri" pitchFamily="34" charset="0"/>
                <a:cs typeface="Calibri" pitchFamily="34" charset="0"/>
              </a:rPr>
              <a:t>Plasma</a:t>
            </a:r>
            <a:endParaRPr lang="ko-KR" altLang="en-US" sz="16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0" y="0"/>
            <a:ext cx="1164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S2</a:t>
            </a:r>
            <a:endParaRPr lang="ko-KR" altLang="en-US" dirty="0"/>
          </a:p>
        </p:txBody>
      </p:sp>
      <p:graphicFrame>
        <p:nvGraphicFramePr>
          <p:cNvPr id="88" name="차트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770427637"/>
              </p:ext>
            </p:extLst>
          </p:nvPr>
        </p:nvGraphicFramePr>
        <p:xfrm>
          <a:off x="964758" y="1487447"/>
          <a:ext cx="4352925" cy="2502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6" name="TextBox 36"/>
          <p:cNvSpPr txBox="1">
            <a:spLocks noChangeArrowheads="1"/>
          </p:cNvSpPr>
          <p:nvPr/>
        </p:nvSpPr>
        <p:spPr bwMode="auto">
          <a:xfrm rot="16200000">
            <a:off x="401505" y="2493467"/>
            <a:ext cx="10096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ko-KR" sz="1200" b="1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Ig</a:t>
            </a:r>
            <a:r>
              <a:rPr lang="en-US" altLang="ko-KR" sz="1200" b="1" dirty="0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 </a:t>
            </a:r>
            <a:r>
              <a:rPr kumimoji="0" lang="en-US" altLang="ko-KR" sz="1200" b="1" dirty="0" err="1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ng</a:t>
            </a:r>
            <a:r>
              <a:rPr kumimoji="0" lang="en-US" altLang="ko-KR" sz="1200" b="1" dirty="0" smtClean="0">
                <a:latin typeface="Calibri" pitchFamily="34" charset="0"/>
                <a:ea typeface="맑은 고딕" pitchFamily="50" charset="-127"/>
                <a:cs typeface="Calibri" pitchFamily="34" charset="0"/>
              </a:rPr>
              <a:t>/ml</a:t>
            </a:r>
            <a:endParaRPr kumimoji="0" lang="ko-KR" altLang="en-US" sz="1200" b="1" dirty="0">
              <a:latin typeface="Calibri" pitchFamily="34" charset="0"/>
              <a:ea typeface="맑은 고딕" pitchFamily="50" charset="-127"/>
              <a:cs typeface="Calibri" pitchFamily="34" charset="0"/>
            </a:endParaRPr>
          </a:p>
        </p:txBody>
      </p:sp>
      <p:sp>
        <p:nvSpPr>
          <p:cNvPr id="91" name="TextBox 214"/>
          <p:cNvSpPr txBox="1">
            <a:spLocks noChangeArrowheads="1"/>
          </p:cNvSpPr>
          <p:nvPr/>
        </p:nvSpPr>
        <p:spPr bwMode="auto">
          <a:xfrm>
            <a:off x="4550682" y="1593727"/>
            <a:ext cx="46001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 *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90" name="TextBox 215"/>
          <p:cNvSpPr txBox="1">
            <a:spLocks noChangeArrowheads="1"/>
          </p:cNvSpPr>
          <p:nvPr/>
        </p:nvSpPr>
        <p:spPr bwMode="auto">
          <a:xfrm>
            <a:off x="4440889" y="1507478"/>
            <a:ext cx="2863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 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05" name="TextBox 214"/>
          <p:cNvSpPr txBox="1">
            <a:spLocks noChangeArrowheads="1"/>
          </p:cNvSpPr>
          <p:nvPr/>
        </p:nvSpPr>
        <p:spPr bwMode="auto">
          <a:xfrm>
            <a:off x="6526023" y="1593727"/>
            <a:ext cx="47185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*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04" name="TextBox 215"/>
          <p:cNvSpPr txBox="1">
            <a:spLocks noChangeArrowheads="1"/>
          </p:cNvSpPr>
          <p:nvPr/>
        </p:nvSpPr>
        <p:spPr bwMode="auto">
          <a:xfrm>
            <a:off x="6669567" y="1481600"/>
            <a:ext cx="40440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1000" dirty="0" smtClean="0">
                <a:latin typeface="Calibri" pitchFamily="34" charset="0"/>
                <a:cs typeface="Calibri" pitchFamily="34" charset="0"/>
              </a:rPr>
              <a:t> **</a:t>
            </a:r>
            <a:endParaRPr lang="ko-KR" altLang="en-US" sz="1000" dirty="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63" name="왼쪽 대괄호 62"/>
          <p:cNvSpPr/>
          <p:nvPr/>
        </p:nvSpPr>
        <p:spPr>
          <a:xfrm rot="5400000">
            <a:off x="3348273" y="1019140"/>
            <a:ext cx="55060" cy="6153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왼쪽 대괄호 64"/>
          <p:cNvSpPr/>
          <p:nvPr/>
        </p:nvSpPr>
        <p:spPr>
          <a:xfrm rot="5400000">
            <a:off x="4698307" y="1601426"/>
            <a:ext cx="63686" cy="3048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왼쪽 대괄호 66"/>
          <p:cNvSpPr/>
          <p:nvPr/>
        </p:nvSpPr>
        <p:spPr>
          <a:xfrm rot="5400000">
            <a:off x="6662255" y="1615802"/>
            <a:ext cx="63686" cy="3048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왼쪽 대괄호 67"/>
          <p:cNvSpPr/>
          <p:nvPr/>
        </p:nvSpPr>
        <p:spPr>
          <a:xfrm rot="5400000">
            <a:off x="3194435" y="1279372"/>
            <a:ext cx="63686" cy="3048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왼쪽 대괄호 68"/>
          <p:cNvSpPr/>
          <p:nvPr/>
        </p:nvSpPr>
        <p:spPr>
          <a:xfrm rot="5400000">
            <a:off x="3502110" y="1279372"/>
            <a:ext cx="63686" cy="3048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왼쪽 대괄호 73"/>
          <p:cNvSpPr/>
          <p:nvPr/>
        </p:nvSpPr>
        <p:spPr>
          <a:xfrm rot="5400000">
            <a:off x="4553096" y="1369950"/>
            <a:ext cx="55060" cy="6153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5" name="왼쪽 대괄호 74"/>
          <p:cNvSpPr/>
          <p:nvPr/>
        </p:nvSpPr>
        <p:spPr>
          <a:xfrm rot="5400000">
            <a:off x="6827595" y="1349822"/>
            <a:ext cx="55060" cy="6153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화면 슬라이드 쇼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y</dc:creator>
  <cp:lastModifiedBy>y</cp:lastModifiedBy>
  <cp:revision>1</cp:revision>
  <dcterms:created xsi:type="dcterms:W3CDTF">2012-12-18T02:30:25Z</dcterms:created>
  <dcterms:modified xsi:type="dcterms:W3CDTF">2012-12-18T02:30:48Z</dcterms:modified>
</cp:coreProperties>
</file>